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3" r:id="rId2"/>
    <p:sldId id="257" r:id="rId3"/>
    <p:sldId id="264" r:id="rId4"/>
    <p:sldId id="259" r:id="rId5"/>
    <p:sldId id="265" r:id="rId6"/>
    <p:sldId id="262" r:id="rId7"/>
    <p:sldId id="261" r:id="rId8"/>
  </p:sldIdLst>
  <p:sldSz cx="4068763" cy="3060700"/>
  <p:notesSz cx="6858000" cy="9144000"/>
  <p:defaultTextStyle>
    <a:defPPr>
      <a:defRPr lang="fr-FR"/>
    </a:defPPr>
    <a:lvl1pPr marL="0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1pPr>
    <a:lvl2pPr marL="203683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2pPr>
    <a:lvl3pPr marL="407365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3pPr>
    <a:lvl4pPr marL="611048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4pPr>
    <a:lvl5pPr marL="814730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5pPr>
    <a:lvl6pPr marL="1018413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6pPr>
    <a:lvl7pPr marL="1222096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7pPr>
    <a:lvl8pPr marL="1425778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8pPr>
    <a:lvl9pPr marL="1629461" algn="l" defTabSz="407365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232" d="100"/>
          <a:sy n="232" d="100"/>
        </p:scale>
        <p:origin x="-372" y="-84"/>
      </p:cViewPr>
      <p:guideLst>
        <p:guide orient="horz" pos="964"/>
        <p:guide pos="12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customXml" Target="../customXml/item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customXml" Target="../customXml/item2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dicataldo\Documents\Th&#232;se\2014-2015\Article%20M2\Graphs%20article%20M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dicataldo\Desktop\Cl&#233;%20USB\Pour%20travailler\Tableau%20souris%20M2%20(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dicataldo\Documents\Th&#232;se\2013-2014\Article%20Erica-Moi\ITT%20C5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euil1!$B$25:$C$25</c:f>
                <c:numCache>
                  <c:formatCode>General</c:formatCode>
                  <c:ptCount val="2"/>
                  <c:pt idx="0">
                    <c:v>3.28</c:v>
                  </c:pt>
                  <c:pt idx="1">
                    <c:v>3.35</c:v>
                  </c:pt>
                </c:numCache>
              </c:numRef>
            </c:plus>
            <c:minus>
              <c:numRef>
                <c:f>Feuil1!$B$25:$C$25</c:f>
                <c:numCache>
                  <c:formatCode>General</c:formatCode>
                  <c:ptCount val="2"/>
                  <c:pt idx="0">
                    <c:v>3.28</c:v>
                  </c:pt>
                  <c:pt idx="1">
                    <c:v>3.35</c:v>
                  </c:pt>
                </c:numCache>
              </c:numRef>
            </c:minus>
          </c:errBars>
          <c:cat>
            <c:strRef>
              <c:f>Feuil1!$B$23:$C$23</c:f>
              <c:strCache>
                <c:ptCount val="2"/>
                <c:pt idx="0">
                  <c:v>ApoE-/- SED</c:v>
                </c:pt>
                <c:pt idx="1">
                  <c:v>ApoE-/- EX</c:v>
                </c:pt>
              </c:strCache>
            </c:strRef>
          </c:cat>
          <c:val>
            <c:numRef>
              <c:f>Feuil1!$B$24:$C$24</c:f>
              <c:numCache>
                <c:formatCode>General</c:formatCode>
                <c:ptCount val="2"/>
                <c:pt idx="0">
                  <c:v>35.700000000000003</c:v>
                </c:pt>
                <c:pt idx="1">
                  <c:v>33.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555328"/>
        <c:axId val="89556864"/>
      </c:barChart>
      <c:catAx>
        <c:axId val="89555328"/>
        <c:scaling>
          <c:orientation val="minMax"/>
        </c:scaling>
        <c:delete val="0"/>
        <c:axPos val="b"/>
        <c:majorTickMark val="out"/>
        <c:minorTickMark val="none"/>
        <c:tickLblPos val="nextTo"/>
        <c:crossAx val="89556864"/>
        <c:crosses val="autoZero"/>
        <c:auto val="1"/>
        <c:lblAlgn val="ctr"/>
        <c:lblOffset val="100"/>
        <c:noMultiLvlLbl val="0"/>
      </c:catAx>
      <c:valAx>
        <c:axId val="8955686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at index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95553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euil2!$E$56</c:f>
              <c:strCache>
                <c:ptCount val="1"/>
                <c:pt idx="0">
                  <c:v>ApoE-/- SED before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F$60:$I$60</c:f>
                <c:numCache>
                  <c:formatCode>General</c:formatCode>
                  <c:ptCount val="4"/>
                  <c:pt idx="0">
                    <c:v>6.2057321172534605</c:v>
                  </c:pt>
                  <c:pt idx="1">
                    <c:v>8.9134729482957447</c:v>
                  </c:pt>
                  <c:pt idx="2">
                    <c:v>15.504121315888161</c:v>
                  </c:pt>
                  <c:pt idx="3">
                    <c:v>21.397429752192203</c:v>
                  </c:pt>
                </c:numCache>
              </c:numRef>
            </c:plus>
            <c:minus>
              <c:numRef>
                <c:f>Feuil2!$F$60:$I$60</c:f>
                <c:numCache>
                  <c:formatCode>General</c:formatCode>
                  <c:ptCount val="4"/>
                  <c:pt idx="0">
                    <c:v>6.2057321172534605</c:v>
                  </c:pt>
                  <c:pt idx="1">
                    <c:v>8.9134729482957447</c:v>
                  </c:pt>
                  <c:pt idx="2">
                    <c:v>15.504121315888161</c:v>
                  </c:pt>
                  <c:pt idx="3">
                    <c:v>21.397429752192203</c:v>
                  </c:pt>
                </c:numCache>
              </c:numRef>
            </c:minus>
          </c:errBars>
          <c:cat>
            <c:strRef>
              <c:f>Feuil2!$F$55:$I$55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2!$F$56:$I$56</c:f>
              <c:numCache>
                <c:formatCode>General</c:formatCode>
                <c:ptCount val="4"/>
                <c:pt idx="0">
                  <c:v>172.33333333333334</c:v>
                </c:pt>
                <c:pt idx="1">
                  <c:v>164.5</c:v>
                </c:pt>
                <c:pt idx="2">
                  <c:v>129.66666666666666</c:v>
                </c:pt>
                <c:pt idx="3">
                  <c:v>116.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euil2!$E$57</c:f>
              <c:strCache>
                <c:ptCount val="1"/>
                <c:pt idx="0">
                  <c:v>ApoE-/- SED after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F$61:$I$61</c:f>
                <c:numCache>
                  <c:formatCode>General</c:formatCode>
                  <c:ptCount val="4"/>
                  <c:pt idx="0">
                    <c:v>17.263963752407637</c:v>
                  </c:pt>
                  <c:pt idx="1">
                    <c:v>26.477663542440201</c:v>
                  </c:pt>
                  <c:pt idx="2">
                    <c:v>25.141930448290296</c:v>
                  </c:pt>
                  <c:pt idx="3">
                    <c:v>27.360149447285146</c:v>
                  </c:pt>
                </c:numCache>
              </c:numRef>
            </c:plus>
            <c:minus>
              <c:numRef>
                <c:f>Feuil2!$F$61:$I$61</c:f>
                <c:numCache>
                  <c:formatCode>General</c:formatCode>
                  <c:ptCount val="4"/>
                  <c:pt idx="0">
                    <c:v>17.263963752407637</c:v>
                  </c:pt>
                  <c:pt idx="1">
                    <c:v>26.477663542440201</c:v>
                  </c:pt>
                  <c:pt idx="2">
                    <c:v>25.141930448290296</c:v>
                  </c:pt>
                  <c:pt idx="3">
                    <c:v>27.360149447285146</c:v>
                  </c:pt>
                </c:numCache>
              </c:numRef>
            </c:minus>
          </c:errBars>
          <c:cat>
            <c:strRef>
              <c:f>Feuil2!$F$55:$I$55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2!$F$57:$I$57</c:f>
              <c:numCache>
                <c:formatCode>General</c:formatCode>
                <c:ptCount val="4"/>
                <c:pt idx="0">
                  <c:v>198.66666666666666</c:v>
                </c:pt>
                <c:pt idx="1">
                  <c:v>146</c:v>
                </c:pt>
                <c:pt idx="2">
                  <c:v>123.5</c:v>
                </c:pt>
                <c:pt idx="3">
                  <c:v>113.6666666666666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euil2!$E$58</c:f>
              <c:strCache>
                <c:ptCount val="1"/>
                <c:pt idx="0">
                  <c:v>ApoE-/- EX before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F$62:$I$62</c:f>
                <c:numCache>
                  <c:formatCode>General</c:formatCode>
                  <c:ptCount val="4"/>
                  <c:pt idx="0">
                    <c:v>8.74414089547966</c:v>
                  </c:pt>
                  <c:pt idx="1">
                    <c:v>11.616367762773359</c:v>
                  </c:pt>
                  <c:pt idx="2">
                    <c:v>17.627818923508379</c:v>
                  </c:pt>
                  <c:pt idx="3">
                    <c:v>12.045746137122432</c:v>
                  </c:pt>
                </c:numCache>
              </c:numRef>
            </c:plus>
            <c:minus>
              <c:numRef>
                <c:f>Feuil2!$F$62:$I$62</c:f>
                <c:numCache>
                  <c:formatCode>General</c:formatCode>
                  <c:ptCount val="4"/>
                  <c:pt idx="0">
                    <c:v>8.74414089547966</c:v>
                  </c:pt>
                  <c:pt idx="1">
                    <c:v>11.616367762773359</c:v>
                  </c:pt>
                  <c:pt idx="2">
                    <c:v>17.627818923508379</c:v>
                  </c:pt>
                  <c:pt idx="3">
                    <c:v>12.045746137122432</c:v>
                  </c:pt>
                </c:numCache>
              </c:numRef>
            </c:minus>
          </c:errBars>
          <c:cat>
            <c:strRef>
              <c:f>Feuil2!$F$55:$I$55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2!$F$58:$I$58</c:f>
              <c:numCache>
                <c:formatCode>General</c:formatCode>
                <c:ptCount val="4"/>
                <c:pt idx="0">
                  <c:v>147.4</c:v>
                </c:pt>
                <c:pt idx="1">
                  <c:v>159.19999999999999</c:v>
                </c:pt>
                <c:pt idx="2">
                  <c:v>108.2</c:v>
                </c:pt>
                <c:pt idx="3">
                  <c:v>6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euil2!$E$59</c:f>
              <c:strCache>
                <c:ptCount val="1"/>
                <c:pt idx="0">
                  <c:v>ApoE-/- EX after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F$63:$I$63</c:f>
                <c:numCache>
                  <c:formatCode>General</c:formatCode>
                  <c:ptCount val="4"/>
                  <c:pt idx="0">
                    <c:v>20.076354250709976</c:v>
                  </c:pt>
                  <c:pt idx="1">
                    <c:v>19.007893097342482</c:v>
                  </c:pt>
                  <c:pt idx="2">
                    <c:v>19.23382437270342</c:v>
                  </c:pt>
                  <c:pt idx="3">
                    <c:v>20.826905675111696</c:v>
                  </c:pt>
                </c:numCache>
              </c:numRef>
            </c:plus>
            <c:minus>
              <c:numRef>
                <c:f>Feuil2!$F$63:$I$63</c:f>
                <c:numCache>
                  <c:formatCode>General</c:formatCode>
                  <c:ptCount val="4"/>
                  <c:pt idx="0">
                    <c:v>20.076354250709976</c:v>
                  </c:pt>
                  <c:pt idx="1">
                    <c:v>19.007893097342482</c:v>
                  </c:pt>
                  <c:pt idx="2">
                    <c:v>19.23382437270342</c:v>
                  </c:pt>
                  <c:pt idx="3">
                    <c:v>20.826905675111696</c:v>
                  </c:pt>
                </c:numCache>
              </c:numRef>
            </c:minus>
          </c:errBars>
          <c:cat>
            <c:strRef>
              <c:f>Feuil2!$F$55:$I$55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2!$F$59:$I$59</c:f>
              <c:numCache>
                <c:formatCode>General</c:formatCode>
                <c:ptCount val="4"/>
                <c:pt idx="0">
                  <c:v>239.6</c:v>
                </c:pt>
                <c:pt idx="1">
                  <c:v>168</c:v>
                </c:pt>
                <c:pt idx="2">
                  <c:v>133.19999999999999</c:v>
                </c:pt>
                <c:pt idx="3">
                  <c:v>132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9616768"/>
        <c:axId val="89618304"/>
      </c:lineChart>
      <c:catAx>
        <c:axId val="89616768"/>
        <c:scaling>
          <c:orientation val="minMax"/>
        </c:scaling>
        <c:delete val="0"/>
        <c:axPos val="b"/>
        <c:majorTickMark val="out"/>
        <c:minorTickMark val="none"/>
        <c:tickLblPos val="nextTo"/>
        <c:crossAx val="89618304"/>
        <c:crosses val="autoZero"/>
        <c:auto val="1"/>
        <c:lblAlgn val="ctr"/>
        <c:lblOffset val="100"/>
        <c:noMultiLvlLbl val="0"/>
      </c:catAx>
      <c:valAx>
        <c:axId val="89618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Glucose (mg/d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9616768"/>
        <c:crosses val="autoZero"/>
        <c:crossBetween val="between"/>
      </c:valAx>
    </c:plotArea>
    <c:legend>
      <c:legendPos val="b"/>
      <c:layout/>
      <c:overlay val="0"/>
      <c:txPr>
        <a:bodyPr/>
        <a:lstStyle/>
        <a:p>
          <a:pPr>
            <a:defRPr sz="400"/>
          </a:pPr>
          <a:endParaRPr lang="fr-FR"/>
        </a:p>
      </c:txPr>
    </c:legend>
    <c:plotVisOnly val="1"/>
    <c:dispBlanksAs val="gap"/>
    <c:showDLblsOverMax val="0"/>
  </c:chart>
  <c:txPr>
    <a:bodyPr/>
    <a:lstStyle/>
    <a:p>
      <a:pPr>
        <a:defRPr sz="500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euil3!$C$5</c:f>
              <c:strCache>
                <c:ptCount val="1"/>
                <c:pt idx="0">
                  <c:v>WT SED before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3!$D$9:$G$9</c:f>
                <c:numCache>
                  <c:formatCode>General</c:formatCode>
                  <c:ptCount val="4"/>
                  <c:pt idx="0">
                    <c:v>1.1218303799418803</c:v>
                  </c:pt>
                  <c:pt idx="1">
                    <c:v>3.6477558099439147</c:v>
                  </c:pt>
                  <c:pt idx="2">
                    <c:v>2.4771060578361812</c:v>
                  </c:pt>
                  <c:pt idx="3">
                    <c:v>1.7515784912142403</c:v>
                  </c:pt>
                </c:numCache>
              </c:numRef>
            </c:plus>
            <c:minus>
              <c:numRef>
                <c:f>Feuil3!$D$9:$G$9</c:f>
                <c:numCache>
                  <c:formatCode>General</c:formatCode>
                  <c:ptCount val="4"/>
                  <c:pt idx="0">
                    <c:v>1.1218303799418803</c:v>
                  </c:pt>
                  <c:pt idx="1">
                    <c:v>3.6477558099439147</c:v>
                  </c:pt>
                  <c:pt idx="2">
                    <c:v>2.4771060578361812</c:v>
                  </c:pt>
                  <c:pt idx="3">
                    <c:v>1.7515784912142403</c:v>
                  </c:pt>
                </c:numCache>
              </c:numRef>
            </c:minus>
          </c:errBars>
          <c:cat>
            <c:strRef>
              <c:f>Feuil3!$D$4:$G$4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3!$D$5:$G$5</c:f>
              <c:numCache>
                <c:formatCode>General</c:formatCode>
                <c:ptCount val="4"/>
                <c:pt idx="0">
                  <c:v>197.85714285714286</c:v>
                </c:pt>
                <c:pt idx="1">
                  <c:v>127.14285714285714</c:v>
                </c:pt>
                <c:pt idx="2">
                  <c:v>89.571428571428569</c:v>
                </c:pt>
                <c:pt idx="3">
                  <c:v>57.14285714285714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euil3!$C$6</c:f>
              <c:strCache>
                <c:ptCount val="1"/>
                <c:pt idx="0">
                  <c:v>WT SED after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3!$D$10:$G$10</c:f>
                <c:numCache>
                  <c:formatCode>General</c:formatCode>
                  <c:ptCount val="4"/>
                  <c:pt idx="0">
                    <c:v>1.7975796274454166</c:v>
                  </c:pt>
                  <c:pt idx="1">
                    <c:v>4.109885212823472</c:v>
                  </c:pt>
                  <c:pt idx="2">
                    <c:v>2.7503864910845048</c:v>
                  </c:pt>
                  <c:pt idx="3">
                    <c:v>1.7651193326524419</c:v>
                  </c:pt>
                </c:numCache>
              </c:numRef>
            </c:plus>
            <c:minus>
              <c:numRef>
                <c:f>Feuil3!$D$10:$G$10</c:f>
                <c:numCache>
                  <c:formatCode>General</c:formatCode>
                  <c:ptCount val="4"/>
                  <c:pt idx="0">
                    <c:v>1.7975796274454166</c:v>
                  </c:pt>
                  <c:pt idx="1">
                    <c:v>4.109885212823472</c:v>
                  </c:pt>
                  <c:pt idx="2">
                    <c:v>2.7503864910845048</c:v>
                  </c:pt>
                  <c:pt idx="3">
                    <c:v>1.7651193326524419</c:v>
                  </c:pt>
                </c:numCache>
              </c:numRef>
            </c:minus>
          </c:errBars>
          <c:cat>
            <c:strRef>
              <c:f>Feuil3!$D$4:$G$4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3!$D$6:$G$6</c:f>
              <c:numCache>
                <c:formatCode>General</c:formatCode>
                <c:ptCount val="4"/>
                <c:pt idx="0">
                  <c:v>197.57142857142858</c:v>
                </c:pt>
                <c:pt idx="1">
                  <c:v>126.28571428571429</c:v>
                </c:pt>
                <c:pt idx="2">
                  <c:v>90.571428571428569</c:v>
                </c:pt>
                <c:pt idx="3">
                  <c:v>58.14285714285714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euil3!$C$7</c:f>
              <c:strCache>
                <c:ptCount val="1"/>
                <c:pt idx="0">
                  <c:v>WT EX before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3!$D$11:$G$11</c:f>
                <c:numCache>
                  <c:formatCode>General</c:formatCode>
                  <c:ptCount val="4"/>
                  <c:pt idx="0">
                    <c:v>1.4529663145135581</c:v>
                  </c:pt>
                  <c:pt idx="1">
                    <c:v>6.6470544855096048</c:v>
                  </c:pt>
                  <c:pt idx="2">
                    <c:v>2.4358434541926814</c:v>
                  </c:pt>
                  <c:pt idx="3">
                    <c:v>2.2060522810365732</c:v>
                  </c:pt>
                </c:numCache>
              </c:numRef>
            </c:plus>
            <c:minus>
              <c:numRef>
                <c:f>Feuil3!$D$11:$G$11</c:f>
                <c:numCache>
                  <c:formatCode>General</c:formatCode>
                  <c:ptCount val="4"/>
                  <c:pt idx="0">
                    <c:v>1.4529663145135581</c:v>
                  </c:pt>
                  <c:pt idx="1">
                    <c:v>6.6470544855096048</c:v>
                  </c:pt>
                  <c:pt idx="2">
                    <c:v>2.4358434541926814</c:v>
                  </c:pt>
                  <c:pt idx="3">
                    <c:v>2.2060522810365732</c:v>
                  </c:pt>
                </c:numCache>
              </c:numRef>
            </c:minus>
          </c:errBars>
          <c:cat>
            <c:strRef>
              <c:f>Feuil3!$D$4:$G$4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3!$D$7:$G$7</c:f>
              <c:numCache>
                <c:formatCode>General</c:formatCode>
                <c:ptCount val="4"/>
                <c:pt idx="0">
                  <c:v>199.33333333333334</c:v>
                </c:pt>
                <c:pt idx="1">
                  <c:v>121.5</c:v>
                </c:pt>
                <c:pt idx="2">
                  <c:v>88</c:v>
                </c:pt>
                <c:pt idx="3">
                  <c:v>5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euil3!$C$8</c:f>
              <c:strCache>
                <c:ptCount val="1"/>
                <c:pt idx="0">
                  <c:v>WT EX after training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3!$D$12:$G$12</c:f>
                <c:numCache>
                  <c:formatCode>General</c:formatCode>
                  <c:ptCount val="4"/>
                  <c:pt idx="0">
                    <c:v>1.6414763002993507</c:v>
                  </c:pt>
                  <c:pt idx="1">
                    <c:v>7.0364132277113294</c:v>
                  </c:pt>
                  <c:pt idx="2">
                    <c:v>2.2123391341393495</c:v>
                  </c:pt>
                  <c:pt idx="3">
                    <c:v>1.7448336437736536</c:v>
                  </c:pt>
                </c:numCache>
              </c:numRef>
            </c:plus>
            <c:minus>
              <c:numRef>
                <c:f>Feuil3!$D$12:$G$12</c:f>
                <c:numCache>
                  <c:formatCode>General</c:formatCode>
                  <c:ptCount val="4"/>
                  <c:pt idx="0">
                    <c:v>1.6414763002993507</c:v>
                  </c:pt>
                  <c:pt idx="1">
                    <c:v>7.0364132277113294</c:v>
                  </c:pt>
                  <c:pt idx="2">
                    <c:v>2.2123391341393495</c:v>
                  </c:pt>
                  <c:pt idx="3">
                    <c:v>1.7448336437736536</c:v>
                  </c:pt>
                </c:numCache>
              </c:numRef>
            </c:minus>
          </c:errBars>
          <c:cat>
            <c:strRef>
              <c:f>Feuil3!$D$4:$G$4</c:f>
              <c:strCache>
                <c:ptCount val="4"/>
                <c:pt idx="0">
                  <c:v>T0</c:v>
                </c:pt>
                <c:pt idx="1">
                  <c:v>T+15</c:v>
                </c:pt>
                <c:pt idx="2">
                  <c:v>T+30</c:v>
                </c:pt>
                <c:pt idx="3">
                  <c:v>T+45</c:v>
                </c:pt>
              </c:strCache>
            </c:strRef>
          </c:cat>
          <c:val>
            <c:numRef>
              <c:f>Feuil3!$D$8:$G$8</c:f>
              <c:numCache>
                <c:formatCode>General</c:formatCode>
                <c:ptCount val="4"/>
                <c:pt idx="0">
                  <c:v>201.16666666666666</c:v>
                </c:pt>
                <c:pt idx="1">
                  <c:v>122.33333333333333</c:v>
                </c:pt>
                <c:pt idx="2">
                  <c:v>87.833333333333329</c:v>
                </c:pt>
                <c:pt idx="3">
                  <c:v>53.33333333333333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9671552"/>
        <c:axId val="89673088"/>
      </c:lineChart>
      <c:catAx>
        <c:axId val="89671552"/>
        <c:scaling>
          <c:orientation val="minMax"/>
        </c:scaling>
        <c:delete val="0"/>
        <c:axPos val="b"/>
        <c:majorTickMark val="out"/>
        <c:minorTickMark val="none"/>
        <c:tickLblPos val="nextTo"/>
        <c:crossAx val="89673088"/>
        <c:crosses val="autoZero"/>
        <c:auto val="1"/>
        <c:lblAlgn val="ctr"/>
        <c:lblOffset val="100"/>
        <c:noMultiLvlLbl val="0"/>
      </c:catAx>
      <c:valAx>
        <c:axId val="89673088"/>
        <c:scaling>
          <c:orientation val="minMax"/>
          <c:max val="3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Glucose (mg/d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9671552"/>
        <c:crosses val="autoZero"/>
        <c:crossBetween val="between"/>
      </c:valAx>
    </c:plotArea>
    <c:legend>
      <c:legendPos val="b"/>
      <c:layout/>
      <c:overlay val="0"/>
      <c:txPr>
        <a:bodyPr/>
        <a:lstStyle/>
        <a:p>
          <a:pPr>
            <a:defRPr sz="400"/>
          </a:pPr>
          <a:endParaRPr lang="fr-FR"/>
        </a:p>
      </c:txPr>
    </c:legend>
    <c:plotVisOnly val="1"/>
    <c:dispBlanksAs val="gap"/>
    <c:showDLblsOverMax val="0"/>
  </c:chart>
  <c:txPr>
    <a:bodyPr/>
    <a:lstStyle/>
    <a:p>
      <a:pPr>
        <a:defRPr sz="500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068E1B-3D2F-4968-9C45-AA9C34D29482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9350" y="685800"/>
            <a:ext cx="45593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65687D-09F7-4D30-A628-2E98D38B48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06891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1pPr>
    <a:lvl2pPr marL="203683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2pPr>
    <a:lvl3pPr marL="407365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3pPr>
    <a:lvl4pPr marL="611048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4pPr>
    <a:lvl5pPr marL="814730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5pPr>
    <a:lvl6pPr marL="1018413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6pPr>
    <a:lvl7pPr marL="1222096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7pPr>
    <a:lvl8pPr marL="1425778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8pPr>
    <a:lvl9pPr marL="1629461" algn="l" defTabSz="407365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5687D-09F7-4D30-A628-2E98D38B484A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6582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49350" y="685800"/>
            <a:ext cx="4559300" cy="34290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5687D-09F7-4D30-A628-2E98D38B484A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12651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49350" y="685800"/>
            <a:ext cx="4559300" cy="34290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56B688-115F-8743-8708-556FCF796E21}" type="slidenum">
              <a:rPr lang="fr-FR" smtClean="0"/>
              <a:t>7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52624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305157" y="950801"/>
            <a:ext cx="3458449" cy="65606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610315" y="1734397"/>
            <a:ext cx="2848134" cy="78217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36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073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110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147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184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220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257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294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6909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0389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2949853" y="122570"/>
            <a:ext cx="915472" cy="2611514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03438" y="122570"/>
            <a:ext cx="2678602" cy="2611514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3937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3864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21404" y="1966783"/>
            <a:ext cx="3458449" cy="607889"/>
          </a:xfrm>
        </p:spPr>
        <p:txBody>
          <a:bodyPr anchor="t"/>
          <a:lstStyle>
            <a:lvl1pPr algn="l">
              <a:defRPr sz="18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21404" y="1297255"/>
            <a:ext cx="3458449" cy="669528"/>
          </a:xfrm>
        </p:spPr>
        <p:txBody>
          <a:bodyPr anchor="b"/>
          <a:lstStyle>
            <a:lvl1pPr marL="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1pPr>
            <a:lvl2pPr marL="203683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2pPr>
            <a:lvl3pPr marL="407365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3pPr>
            <a:lvl4pPr marL="611048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4pPr>
            <a:lvl5pPr marL="814730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5pPr>
            <a:lvl6pPr marL="1018413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6pPr>
            <a:lvl7pPr marL="1222096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7pPr>
            <a:lvl8pPr marL="1425778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8pPr>
            <a:lvl9pPr marL="1629461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9698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03438" y="714163"/>
            <a:ext cx="1797037" cy="2019921"/>
          </a:xfrm>
        </p:spPr>
        <p:txBody>
          <a:bodyPr/>
          <a:lstStyle>
            <a:lvl1pPr>
              <a:defRPr sz="1200"/>
            </a:lvl1pPr>
            <a:lvl2pPr>
              <a:defRPr sz="1100"/>
            </a:lvl2pPr>
            <a:lvl3pPr>
              <a:defRPr sz="90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068288" y="714163"/>
            <a:ext cx="1797037" cy="2019921"/>
          </a:xfrm>
        </p:spPr>
        <p:txBody>
          <a:bodyPr/>
          <a:lstStyle>
            <a:lvl1pPr>
              <a:defRPr sz="1200"/>
            </a:lvl1pPr>
            <a:lvl2pPr>
              <a:defRPr sz="1100"/>
            </a:lvl2pPr>
            <a:lvl3pPr>
              <a:defRPr sz="90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9009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03438" y="685115"/>
            <a:ext cx="1797744" cy="285523"/>
          </a:xfrm>
        </p:spPr>
        <p:txBody>
          <a:bodyPr anchor="b"/>
          <a:lstStyle>
            <a:lvl1pPr marL="0" indent="0">
              <a:buNone/>
              <a:defRPr sz="1100" b="1"/>
            </a:lvl1pPr>
            <a:lvl2pPr marL="203683" indent="0">
              <a:buNone/>
              <a:defRPr sz="900" b="1"/>
            </a:lvl2pPr>
            <a:lvl3pPr marL="407365" indent="0">
              <a:buNone/>
              <a:defRPr sz="800" b="1"/>
            </a:lvl3pPr>
            <a:lvl4pPr marL="611048" indent="0">
              <a:buNone/>
              <a:defRPr sz="700" b="1"/>
            </a:lvl4pPr>
            <a:lvl5pPr marL="814730" indent="0">
              <a:buNone/>
              <a:defRPr sz="700" b="1"/>
            </a:lvl5pPr>
            <a:lvl6pPr marL="1018413" indent="0">
              <a:buNone/>
              <a:defRPr sz="700" b="1"/>
            </a:lvl6pPr>
            <a:lvl7pPr marL="1222096" indent="0">
              <a:buNone/>
              <a:defRPr sz="700" b="1"/>
            </a:lvl7pPr>
            <a:lvl8pPr marL="1425778" indent="0">
              <a:buNone/>
              <a:defRPr sz="700" b="1"/>
            </a:lvl8pPr>
            <a:lvl9pPr marL="1629461" indent="0">
              <a:buNone/>
              <a:defRPr sz="7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03438" y="970639"/>
            <a:ext cx="1797744" cy="1763445"/>
          </a:xfrm>
        </p:spPr>
        <p:txBody>
          <a:bodyPr/>
          <a:lstStyle>
            <a:lvl1pPr>
              <a:defRPr sz="1100"/>
            </a:lvl1pPr>
            <a:lvl2pPr>
              <a:defRPr sz="900"/>
            </a:lvl2pPr>
            <a:lvl3pPr>
              <a:defRPr sz="8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2066875" y="685115"/>
            <a:ext cx="1798450" cy="285523"/>
          </a:xfrm>
        </p:spPr>
        <p:txBody>
          <a:bodyPr anchor="b"/>
          <a:lstStyle>
            <a:lvl1pPr marL="0" indent="0">
              <a:buNone/>
              <a:defRPr sz="1100" b="1"/>
            </a:lvl1pPr>
            <a:lvl2pPr marL="203683" indent="0">
              <a:buNone/>
              <a:defRPr sz="900" b="1"/>
            </a:lvl2pPr>
            <a:lvl3pPr marL="407365" indent="0">
              <a:buNone/>
              <a:defRPr sz="800" b="1"/>
            </a:lvl3pPr>
            <a:lvl4pPr marL="611048" indent="0">
              <a:buNone/>
              <a:defRPr sz="700" b="1"/>
            </a:lvl4pPr>
            <a:lvl5pPr marL="814730" indent="0">
              <a:buNone/>
              <a:defRPr sz="700" b="1"/>
            </a:lvl5pPr>
            <a:lvl6pPr marL="1018413" indent="0">
              <a:buNone/>
              <a:defRPr sz="700" b="1"/>
            </a:lvl6pPr>
            <a:lvl7pPr marL="1222096" indent="0">
              <a:buNone/>
              <a:defRPr sz="700" b="1"/>
            </a:lvl7pPr>
            <a:lvl8pPr marL="1425778" indent="0">
              <a:buNone/>
              <a:defRPr sz="700" b="1"/>
            </a:lvl8pPr>
            <a:lvl9pPr marL="1629461" indent="0">
              <a:buNone/>
              <a:defRPr sz="7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2066875" y="970639"/>
            <a:ext cx="1798450" cy="1763445"/>
          </a:xfrm>
        </p:spPr>
        <p:txBody>
          <a:bodyPr/>
          <a:lstStyle>
            <a:lvl1pPr>
              <a:defRPr sz="1100"/>
            </a:lvl1pPr>
            <a:lvl2pPr>
              <a:defRPr sz="900"/>
            </a:lvl2pPr>
            <a:lvl3pPr>
              <a:defRPr sz="8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7750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3268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3523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03438" y="121861"/>
            <a:ext cx="1338595" cy="518619"/>
          </a:xfrm>
        </p:spPr>
        <p:txBody>
          <a:bodyPr anchor="b"/>
          <a:lstStyle>
            <a:lvl1pPr algn="l">
              <a:defRPr sz="9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1590773" y="121861"/>
            <a:ext cx="2274552" cy="2612223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03438" y="640480"/>
            <a:ext cx="1338595" cy="2093604"/>
          </a:xfrm>
        </p:spPr>
        <p:txBody>
          <a:bodyPr/>
          <a:lstStyle>
            <a:lvl1pPr marL="0" indent="0">
              <a:buNone/>
              <a:defRPr sz="600"/>
            </a:lvl1pPr>
            <a:lvl2pPr marL="203683" indent="0">
              <a:buNone/>
              <a:defRPr sz="500"/>
            </a:lvl2pPr>
            <a:lvl3pPr marL="407365" indent="0">
              <a:buNone/>
              <a:defRPr sz="400"/>
            </a:lvl3pPr>
            <a:lvl4pPr marL="611048" indent="0">
              <a:buNone/>
              <a:defRPr sz="400"/>
            </a:lvl4pPr>
            <a:lvl5pPr marL="814730" indent="0">
              <a:buNone/>
              <a:defRPr sz="400"/>
            </a:lvl5pPr>
            <a:lvl6pPr marL="1018413" indent="0">
              <a:buNone/>
              <a:defRPr sz="400"/>
            </a:lvl6pPr>
            <a:lvl7pPr marL="1222096" indent="0">
              <a:buNone/>
              <a:defRPr sz="400"/>
            </a:lvl7pPr>
            <a:lvl8pPr marL="1425778" indent="0">
              <a:buNone/>
              <a:defRPr sz="400"/>
            </a:lvl8pPr>
            <a:lvl9pPr marL="1629461" indent="0">
              <a:buNone/>
              <a:defRPr sz="4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0241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97506" y="2142490"/>
            <a:ext cx="2441258" cy="252933"/>
          </a:xfrm>
        </p:spPr>
        <p:txBody>
          <a:bodyPr anchor="b"/>
          <a:lstStyle>
            <a:lvl1pPr algn="l">
              <a:defRPr sz="9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797506" y="273479"/>
            <a:ext cx="2441258" cy="1836420"/>
          </a:xfrm>
        </p:spPr>
        <p:txBody>
          <a:bodyPr/>
          <a:lstStyle>
            <a:lvl1pPr marL="0" indent="0">
              <a:buNone/>
              <a:defRPr sz="1400"/>
            </a:lvl1pPr>
            <a:lvl2pPr marL="203683" indent="0">
              <a:buNone/>
              <a:defRPr sz="1200"/>
            </a:lvl2pPr>
            <a:lvl3pPr marL="407365" indent="0">
              <a:buNone/>
              <a:defRPr sz="1100"/>
            </a:lvl3pPr>
            <a:lvl4pPr marL="611048" indent="0">
              <a:buNone/>
              <a:defRPr sz="900"/>
            </a:lvl4pPr>
            <a:lvl5pPr marL="814730" indent="0">
              <a:buNone/>
              <a:defRPr sz="900"/>
            </a:lvl5pPr>
            <a:lvl6pPr marL="1018413" indent="0">
              <a:buNone/>
              <a:defRPr sz="900"/>
            </a:lvl6pPr>
            <a:lvl7pPr marL="1222096" indent="0">
              <a:buNone/>
              <a:defRPr sz="900"/>
            </a:lvl7pPr>
            <a:lvl8pPr marL="1425778" indent="0">
              <a:buNone/>
              <a:defRPr sz="900"/>
            </a:lvl8pPr>
            <a:lvl9pPr marL="1629461" indent="0">
              <a:buNone/>
              <a:defRPr sz="9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797506" y="2395423"/>
            <a:ext cx="2441258" cy="359207"/>
          </a:xfrm>
        </p:spPr>
        <p:txBody>
          <a:bodyPr/>
          <a:lstStyle>
            <a:lvl1pPr marL="0" indent="0">
              <a:buNone/>
              <a:defRPr sz="600"/>
            </a:lvl1pPr>
            <a:lvl2pPr marL="203683" indent="0">
              <a:buNone/>
              <a:defRPr sz="500"/>
            </a:lvl2pPr>
            <a:lvl3pPr marL="407365" indent="0">
              <a:buNone/>
              <a:defRPr sz="400"/>
            </a:lvl3pPr>
            <a:lvl4pPr marL="611048" indent="0">
              <a:buNone/>
              <a:defRPr sz="400"/>
            </a:lvl4pPr>
            <a:lvl5pPr marL="814730" indent="0">
              <a:buNone/>
              <a:defRPr sz="400"/>
            </a:lvl5pPr>
            <a:lvl6pPr marL="1018413" indent="0">
              <a:buNone/>
              <a:defRPr sz="400"/>
            </a:lvl6pPr>
            <a:lvl7pPr marL="1222096" indent="0">
              <a:buNone/>
              <a:defRPr sz="400"/>
            </a:lvl7pPr>
            <a:lvl8pPr marL="1425778" indent="0">
              <a:buNone/>
              <a:defRPr sz="400"/>
            </a:lvl8pPr>
            <a:lvl9pPr marL="1629461" indent="0">
              <a:buNone/>
              <a:defRPr sz="4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7795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203438" y="122570"/>
            <a:ext cx="3661887" cy="510117"/>
          </a:xfrm>
          <a:prstGeom prst="rect">
            <a:avLst/>
          </a:prstGeom>
        </p:spPr>
        <p:txBody>
          <a:bodyPr vert="horz" lIns="40737" tIns="20368" rIns="40737" bIns="20368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03438" y="714163"/>
            <a:ext cx="3661887" cy="2019921"/>
          </a:xfrm>
          <a:prstGeom prst="rect">
            <a:avLst/>
          </a:prstGeom>
        </p:spPr>
        <p:txBody>
          <a:bodyPr vert="horz" lIns="40737" tIns="20368" rIns="40737" bIns="20368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203438" y="2836816"/>
            <a:ext cx="949378" cy="162954"/>
          </a:xfrm>
          <a:prstGeom prst="rect">
            <a:avLst/>
          </a:prstGeom>
        </p:spPr>
        <p:txBody>
          <a:bodyPr vert="horz" lIns="40737" tIns="20368" rIns="40737" bIns="20368" rtlCol="0" anchor="ctr"/>
          <a:lstStyle>
            <a:lvl1pPr algn="l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F43A7-6A28-4639-A754-E2591B118331}" type="datetimeFigureOut">
              <a:rPr lang="fr-FR" smtClean="0"/>
              <a:t>22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1390161" y="2836816"/>
            <a:ext cx="1288442" cy="162954"/>
          </a:xfrm>
          <a:prstGeom prst="rect">
            <a:avLst/>
          </a:prstGeom>
        </p:spPr>
        <p:txBody>
          <a:bodyPr vert="horz" lIns="40737" tIns="20368" rIns="40737" bIns="20368" rtlCol="0" anchor="ctr"/>
          <a:lstStyle>
            <a:lvl1pPr algn="ctr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2915947" y="2836816"/>
            <a:ext cx="949378" cy="162954"/>
          </a:xfrm>
          <a:prstGeom prst="rect">
            <a:avLst/>
          </a:prstGeom>
        </p:spPr>
        <p:txBody>
          <a:bodyPr vert="horz" lIns="40737" tIns="20368" rIns="40737" bIns="20368" rtlCol="0" anchor="ctr"/>
          <a:lstStyle>
            <a:lvl1pPr algn="r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E0696-2235-452E-A96F-F5D215D26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7577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07365" rtl="0" eaLnBrk="1" latinLnBrk="0" hangingPunct="1">
        <a:spcBef>
          <a:spcPct val="0"/>
        </a:spcBef>
        <a:buNone/>
        <a:defRPr sz="2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762" indent="-152762" algn="l" defTabSz="407365" rtl="0" eaLnBrk="1" latinLnBrk="0" hangingPunct="1">
        <a:spcBef>
          <a:spcPct val="200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30984" indent="-127302" algn="l" defTabSz="407365" rtl="0" eaLnBrk="1" latinLnBrk="0" hangingPunct="1">
        <a:spcBef>
          <a:spcPct val="20000"/>
        </a:spcBef>
        <a:buFont typeface="Arial" panose="020B0604020202020204" pitchFamily="34" charset="0"/>
        <a:buChar char="–"/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509207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712889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–"/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916572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»"/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120254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323937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527620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731302" indent="-101841" algn="l" defTabSz="407365" rtl="0" eaLnBrk="1" latinLnBrk="0" hangingPunct="1">
        <a:spcBef>
          <a:spcPct val="2000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1pPr>
      <a:lvl2pPr marL="203683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2pPr>
      <a:lvl3pPr marL="407365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3pPr>
      <a:lvl4pPr marL="611048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4pPr>
      <a:lvl5pPr marL="814730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5pPr>
      <a:lvl6pPr marL="1018413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6pPr>
      <a:lvl7pPr marL="1222096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7pPr>
      <a:lvl8pPr marL="1425778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8pPr>
      <a:lvl9pPr marL="1629461" algn="l" defTabSz="407365" rtl="0" eaLnBrk="1" latinLnBrk="0" hangingPunct="1">
        <a:defRPr sz="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896924" y="52052"/>
            <a:ext cx="227491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s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143959" y="450230"/>
            <a:ext cx="3620640" cy="219557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  <a:r>
              <a:rPr lang="fr-F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fr-F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endParaRPr lang="fr-FR" sz="7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fr-FR" sz="7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in </a:t>
            </a:r>
            <a:r>
              <a:rPr lang="fr-FR" sz="7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fr-F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MRI brain coronal localizers and anatomical references for careful pre and post-contrast registration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2 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RE and T2* multi-slice multi-echo gradient echo (MGE) sequence positioned were acquired in the axial plane. 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RE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ing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R/TE = 4000 / 69 ms;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eld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ew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 x 2 cm; matrix = 256 x 256; slice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cknes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 mm; RARE factor= 8,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ices 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15. The MGE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ing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R / first TE = 1500 / 3.2 ms; flip angle = 75°;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eld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ew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 x 2 cm; matrix = 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2 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 192; slice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cknes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 mm; 12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hoes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ho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7.2 ms; </a:t>
            </a:r>
            <a:r>
              <a:rPr lang="fr-F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ices = 15.</a:t>
            </a:r>
            <a:endParaRPr lang="fr-FR" sz="7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fr-F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vascular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sion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on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osit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ssed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line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2 and T2*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2* quantification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MGE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For BBB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meability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e T1-weighted MGE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cal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ometrical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quired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the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TR/TE = 124 / 2.8 ms;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eld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ew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2 x 2 cm; matrix = 256 x 192; slice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cknes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 mm;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slices = 15.</a:t>
            </a:r>
          </a:p>
          <a:p>
            <a:pPr algn="just"/>
            <a:endParaRPr lang="fr-F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7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</a:t>
            </a:r>
            <a:r>
              <a:rPr lang="fr-FR" sz="7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algn="just"/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raining glucose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ime point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e-</a:t>
            </a:r>
            <a:r>
              <a:rPr lang="fr-FR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y</a:t>
            </a:r>
            <a:r>
              <a:rPr lang="fr-FR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OVA. 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significance was determined by a </a:t>
            </a:r>
            <a:r>
              <a:rPr 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</a:t>
            </a:r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less than 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.</a:t>
            </a:r>
            <a:endParaRPr lang="fr-F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6101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43959" y="497361"/>
            <a:ext cx="3620640" cy="2257125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en-US" sz="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 :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ight measurement of visceral and subcutaneous adipose tissues in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 (SED)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ercise trained (EX)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en-US" sz="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. SED and EX WT mice values are given for reference.</a:t>
            </a:r>
          </a:p>
          <a:p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6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2:</a:t>
            </a:r>
            <a:r>
              <a: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ased pro-inflammatory cytokines (IL-1β and TNFα) and oxidative stress markers (AOPP and SOD) concentration in aorta and plasma of both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D and EX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en-US" sz="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SED and EX WT mice values are given for reference.</a:t>
            </a:r>
          </a:p>
          <a:p>
            <a:endParaRPr lang="en-US" sz="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6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</a:t>
            </a:r>
            <a:r>
              <a: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dominal MRI of fat mass of a SED (A) and an EX ApoE</a:t>
            </a:r>
            <a:r>
              <a:rPr lang="en-US" sz="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se (B) and fat mass index (C) of ApoE</a:t>
            </a:r>
            <a:r>
              <a:rPr lang="en-US" sz="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after the 12-weeks training. EX mice showed no apparent differences of fat distribution compared to SED mice (C). In both EX and SED ApoE</a:t>
            </a:r>
            <a:r>
              <a:rPr lang="en-US" sz="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, localization of the fat depots was typical of the metabolic syndrome (A-B). Of note, the liver signal on the fat image was also higher than normal in both cases (A-B).</a:t>
            </a:r>
            <a:endParaRPr 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6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</a:t>
            </a:r>
            <a:r>
              <a: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aired glucose time-course during insulin tolerance test of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h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D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 ApoE</a:t>
            </a:r>
            <a:r>
              <a:rPr lang="en-US" sz="6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 before and after the twelve-weeks training (A).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 and EX WT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 values are given for reference, before and after the training (B). $ Significantly different from corresponding mice pre-training condition p&lt;0.05; $$ p&lt;0.005.</a:t>
            </a:r>
          </a:p>
          <a:p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6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2* map of SED </a:t>
            </a:r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 ApoE</a:t>
            </a:r>
            <a:r>
              <a:rPr lang="en-US" sz="6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 before the twelve-weeks training (A for SED, D for EX) and after training (B for SED and E for EX), and after training post-USPIOs T2* in SED (C) and EX (F) ApoE</a:t>
            </a:r>
            <a:r>
              <a:rPr lang="en-US" sz="6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 showing phagocytosis activity in periventricular areas. WT mice T2* maps under the same conditions are given for reference, before (G, J) and after training (H-I, K-L; I and L are after training post-USPIOs T2* maps). Display parameters (window width and contrast level) are identically set for all maps (respectively 5500 and 2500). After training, focal low T2* areas are visible in both SED and EX </a:t>
            </a:r>
            <a:r>
              <a:rPr lang="en-US" sz="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en-US" sz="6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rrow, B and E). Inflammation is present around these areas, as shown by post-USPIOs maps (arrow, C and F).</a:t>
            </a:r>
            <a:endParaRPr lang="fr-FR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896924" y="52052"/>
            <a:ext cx="227491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gends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3873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0101230"/>
              </p:ext>
            </p:extLst>
          </p:nvPr>
        </p:nvGraphicFramePr>
        <p:xfrm>
          <a:off x="738237" y="882278"/>
          <a:ext cx="3127327" cy="61039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5357"/>
                <a:gridCol w="716731"/>
                <a:gridCol w="504057"/>
                <a:gridCol w="610394"/>
                <a:gridCol w="610394"/>
                <a:gridCol w="610394"/>
              </a:tblGrid>
              <a:tr h="152598"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E</a:t>
                      </a:r>
                      <a:r>
                        <a:rPr lang="fr-FR" sz="6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/- </a:t>
                      </a:r>
                      <a:endParaRPr lang="fr-FR" sz="6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52598"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D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D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/>
                </a:tc>
              </a:tr>
              <a:tr h="15259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sceral</a:t>
                      </a:r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6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 (g)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 ± 0.5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 ± 0.4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± 0.0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± 0.0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</a:tr>
              <a:tr h="15259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cutaneous</a:t>
                      </a:r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6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 (g)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± 0.9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 ± 0.4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± 0.0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± 0.0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30" marR="7630" marT="7630" marB="0" anchor="ctr">
                    <a:noFill/>
                  </a:tcPr>
                </a:tc>
              </a:tr>
            </a:tbl>
          </a:graphicData>
        </a:graphic>
      </p:graphicFrame>
      <p:cxnSp>
        <p:nvCxnSpPr>
          <p:cNvPr id="6" name="Connecteur droit 5"/>
          <p:cNvCxnSpPr/>
          <p:nvPr/>
        </p:nvCxnSpPr>
        <p:spPr>
          <a:xfrm>
            <a:off x="2682453" y="882278"/>
            <a:ext cx="0" cy="61200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304164" y="2012403"/>
            <a:ext cx="1570012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42532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3485527"/>
              </p:ext>
            </p:extLst>
          </p:nvPr>
        </p:nvGraphicFramePr>
        <p:xfrm>
          <a:off x="304164" y="694791"/>
          <a:ext cx="3589474" cy="115200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578089"/>
                <a:gridCol w="783313"/>
                <a:gridCol w="470039"/>
                <a:gridCol w="507556"/>
                <a:gridCol w="64958"/>
                <a:gridCol w="521551"/>
                <a:gridCol w="663968"/>
              </a:tblGrid>
              <a:tr h="144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fr-FR" sz="5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fr-FR" sz="5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E</a:t>
                      </a:r>
                      <a:r>
                        <a:rPr lang="fr-FR" sz="5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/-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ED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E</a:t>
                      </a:r>
                      <a:r>
                        <a:rPr lang="fr-FR" sz="5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/-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D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</a:tr>
              <a:tr h="144000">
                <a:tc row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RTA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g of 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0.0 ± 400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3.3 ± 216.0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</a:tr>
              <a:tr h="144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g of 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7.4 ± 132.6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0.6 ± 216.6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</a:tr>
              <a:tr h="144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PP (µ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g of 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8 ± 17.3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.3 ± 17.3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</a:tr>
              <a:tr h="144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 (µ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g of </a:t>
                      </a:r>
                      <a:r>
                        <a:rPr lang="en-US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</a:t>
                      </a:r>
                      <a:r>
                        <a:rPr lang="en-US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in)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 ± 0.2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 ± 1.5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 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 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000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β (</a:t>
                      </a:r>
                      <a:r>
                        <a:rPr lang="fr-FR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fr-FR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6.7 ± 208.2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6.7 ± 378.6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.6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.7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.5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5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144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α (pg/mL)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 ± 13.6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 ± 8.0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3 ± 5.6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.4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4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/>
                </a:tc>
              </a:tr>
              <a:tr h="144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PP (µmol/</a:t>
                      </a:r>
                      <a:r>
                        <a:rPr lang="fr-FR" sz="5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</a:t>
                      </a: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1.2 ± 31.8</a:t>
                      </a:r>
                      <a:endParaRPr lang="fr-FR" sz="5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.3 ± 66.3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3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5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 ± </a:t>
                      </a:r>
                      <a:r>
                        <a:rPr lang="fr-FR" sz="5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</a:t>
                      </a:r>
                      <a:endParaRPr lang="fr-FR" sz="5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19779" marR="19779" marT="0" marB="0" anchor="ctr">
                    <a:noFill/>
                  </a:tcPr>
                </a:tc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304164" y="2012403"/>
            <a:ext cx="1570012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8986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522213" y="666254"/>
            <a:ext cx="3024336" cy="1512168"/>
            <a:chOff x="270865" y="341703"/>
            <a:chExt cx="2576338" cy="1134473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791047" y="347952"/>
              <a:ext cx="482208" cy="1056216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7011" y="347952"/>
              <a:ext cx="502020" cy="1056216"/>
            </a:xfrm>
            <a:prstGeom prst="rect">
              <a:avLst/>
            </a:prstGeom>
          </p:spPr>
        </p:pic>
        <p:sp>
          <p:nvSpPr>
            <p:cNvPr id="8" name="Zone de texte 90"/>
            <p:cNvSpPr txBox="1">
              <a:spLocks noChangeArrowheads="1"/>
            </p:cNvSpPr>
            <p:nvPr/>
          </p:nvSpPr>
          <p:spPr bwMode="auto">
            <a:xfrm>
              <a:off x="275760" y="1424342"/>
              <a:ext cx="519438" cy="51834"/>
            </a:xfrm>
            <a:prstGeom prst="rect">
              <a:avLst/>
            </a:prstGeom>
            <a:solidFill>
              <a:srgbClr val="FFFFFF"/>
            </a:solidFill>
            <a:ln w="6350">
              <a:noFill/>
              <a:miter lim="800000"/>
              <a:headEnd/>
              <a:tailEnd/>
            </a:ln>
          </p:spPr>
          <p:txBody>
            <a:bodyPr vert="horz" wrap="square" lIns="30749" tIns="15375" rIns="30749" bIns="15375" numCol="1" anchor="t" anchorCtr="0" compatLnSpc="1">
              <a:prstTxWarp prst="textNoShape">
                <a:avLst/>
              </a:prstTxWarp>
            </a:bodyPr>
            <a:lstStyle/>
            <a:p>
              <a:pPr algn="ctr" defTabSz="307492" fontAlgn="base">
                <a:spcBef>
                  <a:spcPct val="0"/>
                </a:spcBef>
                <a:spcAft>
                  <a:spcPts val="336"/>
                </a:spcAft>
              </a:pPr>
              <a:r>
                <a:rPr lang="fr-FR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oE</a:t>
              </a:r>
              <a:r>
                <a:rPr lang="fr-FR" sz="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/-</a:t>
              </a:r>
              <a:r>
                <a:rPr lang="fr-FR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ED</a:t>
              </a:r>
              <a:endParaRPr lang="fr-FR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 de texte 90"/>
            <p:cNvSpPr txBox="1">
              <a:spLocks noChangeArrowheads="1"/>
            </p:cNvSpPr>
            <p:nvPr/>
          </p:nvSpPr>
          <p:spPr bwMode="auto">
            <a:xfrm>
              <a:off x="769848" y="1424342"/>
              <a:ext cx="494866" cy="51834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vert="horz" wrap="square" lIns="30749" tIns="15375" rIns="30749" bIns="15375" numCol="1" anchor="t" anchorCtr="0" compatLnSpc="1">
              <a:prstTxWarp prst="textNoShape">
                <a:avLst/>
              </a:prstTxWarp>
            </a:bodyPr>
            <a:lstStyle/>
            <a:p>
              <a:pPr algn="ctr" defTabSz="307492" fontAlgn="base">
                <a:spcBef>
                  <a:spcPct val="0"/>
                </a:spcBef>
                <a:spcAft>
                  <a:spcPts val="336"/>
                </a:spcAft>
              </a:pPr>
              <a:r>
                <a:rPr lang="fr-FR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oE</a:t>
              </a:r>
              <a:r>
                <a:rPr lang="fr-FR" sz="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/- </a:t>
              </a:r>
              <a:r>
                <a:rPr lang="fr-FR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</a:t>
              </a:r>
              <a:endParaRPr lang="fr-FR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70865" y="347953"/>
              <a:ext cx="124020" cy="107994"/>
            </a:xfrm>
            <a:prstGeom prst="rect">
              <a:avLst/>
            </a:prstGeom>
            <a:noFill/>
          </p:spPr>
          <p:txBody>
            <a:bodyPr wrap="square" lIns="30749" tIns="15375" rIns="30749" bIns="15375" rtlCol="0">
              <a:spAutoFit/>
            </a:bodyPr>
            <a:lstStyle/>
            <a:p>
              <a:r>
                <a:rPr lang="fr-FR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769849" y="346734"/>
              <a:ext cx="124020" cy="107994"/>
            </a:xfrm>
            <a:prstGeom prst="rect">
              <a:avLst/>
            </a:prstGeom>
            <a:noFill/>
          </p:spPr>
          <p:txBody>
            <a:bodyPr wrap="square" lIns="30749" tIns="15375" rIns="30749" bIns="15375" rtlCol="0">
              <a:spAutoFit/>
            </a:bodyPr>
            <a:lstStyle/>
            <a:p>
              <a:r>
                <a:rPr lang="fr-FR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1530350" y="341703"/>
              <a:ext cx="169980" cy="107994"/>
            </a:xfrm>
            <a:prstGeom prst="rect">
              <a:avLst/>
            </a:prstGeom>
            <a:noFill/>
          </p:spPr>
          <p:txBody>
            <a:bodyPr wrap="square" lIns="30749" tIns="15375" rIns="30749" bIns="15375" rtlCol="0">
              <a:spAutoFit/>
            </a:bodyPr>
            <a:lstStyle/>
            <a:p>
              <a:r>
                <a:rPr lang="fr-F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graphicFrame>
          <p:nvGraphicFramePr>
            <p:cNvPr id="13" name="Graphique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9333197"/>
                </p:ext>
              </p:extLst>
            </p:nvPr>
          </p:nvGraphicFramePr>
          <p:xfrm>
            <a:off x="1505601" y="393755"/>
            <a:ext cx="1341602" cy="9883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14" name="ZoneTexte 13"/>
          <p:cNvSpPr txBox="1"/>
          <p:nvPr/>
        </p:nvSpPr>
        <p:spPr>
          <a:xfrm>
            <a:off x="0" y="2904057"/>
            <a:ext cx="1762259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28669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Graphique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4730115"/>
              </p:ext>
            </p:extLst>
          </p:nvPr>
        </p:nvGraphicFramePr>
        <p:xfrm>
          <a:off x="628" y="656928"/>
          <a:ext cx="2081659" cy="14205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9" name="Connecteur droit 8"/>
          <p:cNvCxnSpPr/>
          <p:nvPr/>
        </p:nvCxnSpPr>
        <p:spPr>
          <a:xfrm flipH="1">
            <a:off x="2034381" y="5434"/>
            <a:ext cx="1" cy="305526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0" y="3427"/>
            <a:ext cx="2034382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E </a:t>
            </a:r>
            <a:r>
              <a:rPr lang="fr-FR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fr-FR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034381" y="5434"/>
            <a:ext cx="2034382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fr-FR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0" y="198255"/>
            <a:ext cx="208041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2066422" y="198255"/>
            <a:ext cx="208041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0" y="2904057"/>
            <a:ext cx="1762259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Graphique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0600426"/>
              </p:ext>
            </p:extLst>
          </p:nvPr>
        </p:nvGraphicFramePr>
        <p:xfrm>
          <a:off x="2044141" y="630250"/>
          <a:ext cx="2024622" cy="1473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1653596" y="1046794"/>
            <a:ext cx="159926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$</a:t>
            </a:r>
            <a:endParaRPr lang="fr-FR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491205" y="754662"/>
            <a:ext cx="296232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$$</a:t>
            </a:r>
            <a:endParaRPr lang="fr-FR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7275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304175" y="91241"/>
            <a:ext cx="825400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3171408" y="91241"/>
            <a:ext cx="826074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13377" y="478336"/>
            <a:ext cx="383072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* </a:t>
            </a:r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endParaRPr lang="fr-FR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-9493" y="1063945"/>
            <a:ext cx="666835" cy="233511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USPIO </a:t>
            </a:r>
          </a:p>
          <a:p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* </a:t>
            </a:r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endParaRPr lang="fr-FR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Zone de texte 90"/>
          <p:cNvSpPr txBox="1">
            <a:spLocks noChangeArrowheads="1"/>
          </p:cNvSpPr>
          <p:nvPr/>
        </p:nvSpPr>
        <p:spPr bwMode="auto">
          <a:xfrm>
            <a:off x="2304175" y="-12221"/>
            <a:ext cx="1716753" cy="174683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</p:spPr>
        <p:txBody>
          <a:bodyPr vert="horz" wrap="square" lIns="40737" tIns="20368" rIns="40737" bIns="20368" numCol="1" anchor="t" anchorCtr="0" compatLnSpc="1">
            <a:prstTxWarp prst="textNoShape">
              <a:avLst/>
            </a:prstTxWarp>
          </a:bodyPr>
          <a:lstStyle/>
          <a:p>
            <a:pPr algn="ctr" defTabSz="200972" fontAlgn="base">
              <a:spcBef>
                <a:spcPct val="0"/>
              </a:spcBef>
              <a:spcAft>
                <a:spcPts val="220"/>
              </a:spcAft>
            </a:pP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fr-FR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 mouse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3"/>
          <a:srcRect l="8167"/>
          <a:stretch/>
        </p:blipFill>
        <p:spPr>
          <a:xfrm>
            <a:off x="3171408" y="216300"/>
            <a:ext cx="826074" cy="632489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4175" y="216300"/>
            <a:ext cx="825400" cy="62918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62885" y="871339"/>
            <a:ext cx="840117" cy="604150"/>
          </a:xfrm>
          <a:prstGeom prst="rect">
            <a:avLst/>
          </a:prstGeom>
        </p:spPr>
      </p:pic>
      <p:sp>
        <p:nvSpPr>
          <p:cNvPr id="24" name="ZoneTexte 23"/>
          <p:cNvSpPr txBox="1"/>
          <p:nvPr/>
        </p:nvSpPr>
        <p:spPr>
          <a:xfrm>
            <a:off x="13377" y="1908923"/>
            <a:ext cx="386910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* </a:t>
            </a:r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endParaRPr lang="fr-FR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-2000" y="2510687"/>
            <a:ext cx="666835" cy="233511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USPIO </a:t>
            </a:r>
          </a:p>
          <a:p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* </a:t>
            </a:r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endParaRPr lang="fr-FR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Zone de texte 90"/>
          <p:cNvSpPr txBox="1">
            <a:spLocks noChangeArrowheads="1"/>
          </p:cNvSpPr>
          <p:nvPr/>
        </p:nvSpPr>
        <p:spPr bwMode="auto">
          <a:xfrm>
            <a:off x="423017" y="1490360"/>
            <a:ext cx="1739529" cy="174683"/>
          </a:xfrm>
          <a:prstGeom prst="rect">
            <a:avLst/>
          </a:prstGeom>
          <a:solidFill>
            <a:srgbClr val="FFFFFF"/>
          </a:solidFill>
          <a:ln w="6350">
            <a:noFill/>
            <a:miter lim="800000"/>
            <a:headEnd/>
            <a:tailEnd/>
          </a:ln>
        </p:spPr>
        <p:txBody>
          <a:bodyPr vert="horz" wrap="square" lIns="40737" tIns="20368" rIns="40737" bIns="20368" numCol="1" anchor="t" anchorCtr="0" compatLnSpc="1">
            <a:prstTxWarp prst="textNoShape">
              <a:avLst/>
            </a:prstTxWarp>
          </a:bodyPr>
          <a:lstStyle/>
          <a:p>
            <a:pPr algn="ctr" defTabSz="200972" fontAlgn="base">
              <a:spcBef>
                <a:spcPct val="0"/>
              </a:spcBef>
              <a:spcAft>
                <a:spcPts val="220"/>
              </a:spcAft>
            </a:pP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 SED mouse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423017" y="1592355"/>
            <a:ext cx="839593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1311330" y="1592355"/>
            <a:ext cx="851216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6"/>
          <a:srcRect b="5881"/>
          <a:stretch/>
        </p:blipFill>
        <p:spPr>
          <a:xfrm>
            <a:off x="1311330" y="1726149"/>
            <a:ext cx="851216" cy="590454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3017" y="1726149"/>
            <a:ext cx="851798" cy="590455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 rotWithShape="1">
          <a:blip r:embed="rId8"/>
          <a:srcRect b="7528"/>
          <a:stretch/>
        </p:blipFill>
        <p:spPr>
          <a:xfrm>
            <a:off x="1311330" y="2342649"/>
            <a:ext cx="851216" cy="569588"/>
          </a:xfrm>
          <a:prstGeom prst="rect">
            <a:avLst/>
          </a:prstGeom>
        </p:spPr>
      </p:pic>
      <p:sp>
        <p:nvSpPr>
          <p:cNvPr id="30" name="Zone de texte 90"/>
          <p:cNvSpPr txBox="1">
            <a:spLocks noChangeArrowheads="1"/>
          </p:cNvSpPr>
          <p:nvPr/>
        </p:nvSpPr>
        <p:spPr bwMode="auto">
          <a:xfrm>
            <a:off x="2290710" y="1486889"/>
            <a:ext cx="1710722" cy="174683"/>
          </a:xfrm>
          <a:prstGeom prst="rect">
            <a:avLst/>
          </a:prstGeom>
          <a:solidFill>
            <a:srgbClr val="FFFFFF"/>
          </a:solidFill>
          <a:ln w="6350">
            <a:noFill/>
            <a:miter lim="800000"/>
            <a:headEnd/>
            <a:tailEnd/>
          </a:ln>
        </p:spPr>
        <p:txBody>
          <a:bodyPr vert="horz" wrap="square" lIns="40737" tIns="20368" rIns="40737" bIns="20368" numCol="1" anchor="t" anchorCtr="0" compatLnSpc="1">
            <a:prstTxWarp prst="textNoShape">
              <a:avLst/>
            </a:prstTxWarp>
          </a:bodyPr>
          <a:lstStyle/>
          <a:p>
            <a:pPr algn="ctr" defTabSz="200972" fontAlgn="base">
              <a:spcBef>
                <a:spcPct val="0"/>
              </a:spcBef>
              <a:spcAft>
                <a:spcPts val="220"/>
              </a:spcAft>
            </a:pP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 EX mouse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2290710" y="1603621"/>
            <a:ext cx="840297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3166482" y="1603621"/>
            <a:ext cx="831001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cxnSp>
        <p:nvCxnSpPr>
          <p:cNvPr id="28" name="Connecteur droit 27"/>
          <p:cNvCxnSpPr/>
          <p:nvPr/>
        </p:nvCxnSpPr>
        <p:spPr>
          <a:xfrm>
            <a:off x="-14825" y="1501643"/>
            <a:ext cx="4076612" cy="0"/>
          </a:xfrm>
          <a:prstGeom prst="line">
            <a:avLst/>
          </a:prstGeom>
          <a:ln w="285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Image 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66482" y="2342649"/>
            <a:ext cx="837586" cy="569588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10"/>
          <a:srcRect r="4275" b="2830"/>
          <a:stretch/>
        </p:blipFill>
        <p:spPr>
          <a:xfrm>
            <a:off x="3166481" y="1726149"/>
            <a:ext cx="837587" cy="59906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90710" y="1726149"/>
            <a:ext cx="843985" cy="599060"/>
          </a:xfrm>
          <a:prstGeom prst="rect">
            <a:avLst/>
          </a:prstGeom>
        </p:spPr>
      </p:pic>
      <p:cxnSp>
        <p:nvCxnSpPr>
          <p:cNvPr id="31" name="Connecteur droit avec flèche 30"/>
          <p:cNvCxnSpPr/>
          <p:nvPr/>
        </p:nvCxnSpPr>
        <p:spPr>
          <a:xfrm flipH="1" flipV="1">
            <a:off x="3714419" y="1142677"/>
            <a:ext cx="114010" cy="76049"/>
          </a:xfrm>
          <a:prstGeom prst="straightConnector1">
            <a:avLst/>
          </a:prstGeom>
          <a:ln w="15875" cmpd="sng"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/>
          <p:cNvCxnSpPr/>
          <p:nvPr/>
        </p:nvCxnSpPr>
        <p:spPr>
          <a:xfrm flipH="1" flipV="1">
            <a:off x="3720379" y="483030"/>
            <a:ext cx="114010" cy="76049"/>
          </a:xfrm>
          <a:prstGeom prst="straightConnector1">
            <a:avLst/>
          </a:prstGeom>
          <a:ln w="15875" cmpd="sng"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Zone de texte 90"/>
          <p:cNvSpPr txBox="1">
            <a:spLocks noChangeArrowheads="1"/>
          </p:cNvSpPr>
          <p:nvPr/>
        </p:nvSpPr>
        <p:spPr bwMode="auto">
          <a:xfrm>
            <a:off x="314754" y="-10356"/>
            <a:ext cx="1873024" cy="174683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</p:spPr>
        <p:txBody>
          <a:bodyPr vert="horz" wrap="square" lIns="40737" tIns="20368" rIns="40737" bIns="20368" numCol="1" anchor="t" anchorCtr="0" compatLnSpc="1">
            <a:prstTxWarp prst="textNoShape">
              <a:avLst/>
            </a:prstTxWarp>
          </a:bodyPr>
          <a:lstStyle/>
          <a:p>
            <a:pPr algn="ctr" defTabSz="200972" fontAlgn="base">
              <a:spcBef>
                <a:spcPct val="0"/>
              </a:spcBef>
              <a:spcAft>
                <a:spcPts val="220"/>
              </a:spcAft>
            </a:pP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fr-FR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D mouse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304164" y="91241"/>
            <a:ext cx="900156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1232224" y="91241"/>
            <a:ext cx="955553" cy="137360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pPr algn="ctr"/>
            <a:r>
              <a:rPr lang="fr-FR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ining</a:t>
            </a:r>
          </a:p>
        </p:txBody>
      </p:sp>
      <p:pic>
        <p:nvPicPr>
          <p:cNvPr id="42" name="Image 4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92781" y="216300"/>
            <a:ext cx="869765" cy="629180"/>
          </a:xfrm>
          <a:prstGeom prst="rect">
            <a:avLst/>
          </a:prstGeom>
        </p:spPr>
      </p:pic>
      <p:pic>
        <p:nvPicPr>
          <p:cNvPr id="43" name="Image 42"/>
          <p:cNvPicPr>
            <a:picLocks noChangeAspect="1"/>
          </p:cNvPicPr>
          <p:nvPr/>
        </p:nvPicPr>
        <p:blipFill rotWithShape="1">
          <a:blip r:embed="rId13"/>
          <a:srcRect r="2257" b="4079"/>
          <a:stretch/>
        </p:blipFill>
        <p:spPr>
          <a:xfrm>
            <a:off x="423017" y="216300"/>
            <a:ext cx="851798" cy="629180"/>
          </a:xfrm>
          <a:prstGeom prst="rect">
            <a:avLst/>
          </a:prstGeom>
        </p:spPr>
      </p:pic>
      <p:pic>
        <p:nvPicPr>
          <p:cNvPr id="44" name="Image 43"/>
          <p:cNvPicPr>
            <a:picLocks noChangeAspect="1"/>
          </p:cNvPicPr>
          <p:nvPr/>
        </p:nvPicPr>
        <p:blipFill rotWithShape="1">
          <a:blip r:embed="rId14"/>
          <a:srcRect b="8502"/>
          <a:stretch/>
        </p:blipFill>
        <p:spPr>
          <a:xfrm>
            <a:off x="1292781" y="871338"/>
            <a:ext cx="869764" cy="577664"/>
          </a:xfrm>
          <a:prstGeom prst="rect">
            <a:avLst/>
          </a:prstGeom>
        </p:spPr>
      </p:pic>
      <p:cxnSp>
        <p:nvCxnSpPr>
          <p:cNvPr id="45" name="Connecteur droit avec flèche 44"/>
          <p:cNvCxnSpPr/>
          <p:nvPr/>
        </p:nvCxnSpPr>
        <p:spPr>
          <a:xfrm flipV="1">
            <a:off x="1473477" y="1135389"/>
            <a:ext cx="148480" cy="76049"/>
          </a:xfrm>
          <a:prstGeom prst="straightConnector1">
            <a:avLst/>
          </a:prstGeom>
          <a:ln w="15875" cmpd="sng"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avec flèche 45"/>
          <p:cNvCxnSpPr/>
          <p:nvPr/>
        </p:nvCxnSpPr>
        <p:spPr>
          <a:xfrm flipV="1">
            <a:off x="1485777" y="490419"/>
            <a:ext cx="148480" cy="76049"/>
          </a:xfrm>
          <a:prstGeom prst="straightConnector1">
            <a:avLst/>
          </a:prstGeom>
          <a:ln w="15875" cmpd="sng"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ZoneTexte 46"/>
          <p:cNvSpPr txBox="1"/>
          <p:nvPr/>
        </p:nvSpPr>
        <p:spPr>
          <a:xfrm>
            <a:off x="0" y="2904057"/>
            <a:ext cx="1762259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423017" y="679818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3171409" y="685665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2304175" y="679818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1297437" y="1281612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297437" y="679818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1312893" y="2736773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1311094" y="2151380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423017" y="2151771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3171409" y="1301187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3162551" y="2157563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2290710" y="2159985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3167299" y="2736773"/>
            <a:ext cx="137476" cy="164832"/>
          </a:xfrm>
          <a:prstGeom prst="rect">
            <a:avLst/>
          </a:prstGeom>
          <a:noFill/>
        </p:spPr>
        <p:txBody>
          <a:bodyPr wrap="square" lIns="40737" tIns="20368" rIns="40737" bIns="20368" rtlCol="0">
            <a:spAutoFit/>
          </a:bodyPr>
          <a:lstStyle/>
          <a:p>
            <a:r>
              <a:rPr lang="fr-F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fr-FR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9280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60B5103AB94254DA7D5FDB4723054EE" ma:contentTypeVersion="7" ma:contentTypeDescription="Create a new document." ma:contentTypeScope="" ma:versionID="e6ff7c73bc6dc7908f419cf3f6f9f29a">
  <xsd:schema xmlns:xsd="http://www.w3.org/2001/XMLSchema" xmlns:p="http://schemas.microsoft.com/office/2006/metadata/properties" xmlns:ns2="a818834e-fc69-4d93-b923-1d3865ed6565" targetNamespace="http://schemas.microsoft.com/office/2006/metadata/properties" ma:root="true" ma:fieldsID="7b916731cad182383755141d58573942" ns2:_="">
    <xsd:import namespace="a818834e-fc69-4d93-b923-1d3865ed6565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818834e-fc69-4d93-b923-1d3865ed6565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a818834e-fc69-4d93-b923-1d3865ed6565">false</IsDeleted>
    <FileFormat xmlns="a818834e-fc69-4d93-b923-1d3865ed6565">PPTX</FileFormat>
    <DocumentType xmlns="a818834e-fc69-4d93-b923-1d3865ed6565">Presentation</DocumentType>
    <TitleName xmlns="a818834e-fc69-4d93-b923-1d3865ed6565">Presentation 1.PPTX</TitleName>
    <Checked_x0020_Out_x0020_To xmlns="a818834e-fc69-4d93-b923-1d3865ed6565">
      <UserInfo>
        <DisplayName/>
        <AccountId xsi:nil="true"/>
        <AccountType/>
      </UserInfo>
    </Checked_x0020_Out_x0020_To>
    <StageName xmlns="a818834e-fc69-4d93-b923-1d3865ed6565" xsi:nil="true"/>
    <DocumentId xmlns="a818834e-fc69-4d93-b923-1d3865ed6565">Presentation 1.PPTX</DocumentId>
  </documentManagement>
</p:properties>
</file>

<file path=customXml/itemProps1.xml><?xml version="1.0" encoding="utf-8"?>
<ds:datastoreItem xmlns:ds="http://schemas.openxmlformats.org/officeDocument/2006/customXml" ds:itemID="{248E6478-C57A-4EB5-85DE-91C79779E19E}"/>
</file>

<file path=customXml/itemProps2.xml><?xml version="1.0" encoding="utf-8"?>
<ds:datastoreItem xmlns:ds="http://schemas.openxmlformats.org/officeDocument/2006/customXml" ds:itemID="{533024D5-1D1C-4547-B822-09055A822454}"/>
</file>

<file path=customXml/itemProps3.xml><?xml version="1.0" encoding="utf-8"?>
<ds:datastoreItem xmlns:ds="http://schemas.openxmlformats.org/officeDocument/2006/customXml" ds:itemID="{53FF462F-EDBD-4F9B-BCC3-00888081C8A4}"/>
</file>

<file path=docProps/app.xml><?xml version="1.0" encoding="utf-8"?>
<Properties xmlns="http://schemas.openxmlformats.org/officeDocument/2006/extended-properties" xmlns:vt="http://schemas.openxmlformats.org/officeDocument/2006/docPropsVTypes">
  <TotalTime>1193</TotalTime>
  <Words>321</Words>
  <Application>Microsoft Office PowerPoint</Application>
  <PresentationFormat>Personnalisé</PresentationFormat>
  <Paragraphs>140</Paragraphs>
  <Slides>7</Slides>
  <Notes>3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8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nessa Di cataldo</dc:creator>
  <cp:lastModifiedBy>Vanessa Di cataldo</cp:lastModifiedBy>
  <cp:revision>45</cp:revision>
  <dcterms:created xsi:type="dcterms:W3CDTF">2016-06-24T12:50:24Z</dcterms:created>
  <dcterms:modified xsi:type="dcterms:W3CDTF">2016-08-22T14:21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60B5103AB94254DA7D5FDB4723054EE</vt:lpwstr>
  </property>
</Properties>
</file>